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BCD3E-1200-444B-B4A1-D6160C634C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20CCB-21CE-47C3-B95A-93D270A9E0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0B94A-3CA7-4FC1-852F-629CFEA853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71FF3-762F-4714-973D-99CD2AC457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0CADA-8517-4141-B3E7-6AAD40A6CE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B4DD9-6EA6-46CE-A7E4-8F903BAD61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BB01A-111D-43DD-B6E0-CF5BC701B3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4AB94-2B95-41E2-9CF1-C830D5C08F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E8BC7-92DC-4700-B197-7D8862A3FE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CA8EA-FA32-431F-B82F-F67605B297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C8D0E2-55B8-4AAE-966E-61CA20FB43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3AA4AF-2D19-4AAB-8F6A-1FAAB8277D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FE3485-A6BA-4009-B4AD-8DB76DAAE8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11120" y="5576760"/>
            <a:ext cx="302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Tabl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70800" y="1021680"/>
            <a:ext cx="819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lationship between the miRNA-21 in plasma and primary ESCC tissue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434880" y="1628640"/>
            <a:ext cx="8280360" cy="337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395280" y="5589720"/>
            <a:ext cx="302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Tabl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12560" y="948600"/>
            <a:ext cx="832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lationship between the miRNA-375 in plasma and primary ESCC tissue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468360" y="1557360"/>
            <a:ext cx="8207280" cy="347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0" y="6491160"/>
            <a:ext cx="302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939960" y="1701720"/>
            <a:ext cx="3446280" cy="3309120"/>
            <a:chOff x="939960" y="1701720"/>
            <a:chExt cx="3446280" cy="3309120"/>
          </a:xfrm>
        </p:grpSpPr>
        <p:sp>
          <p:nvSpPr>
            <p:cNvPr id="49" name=""/>
            <p:cNvSpPr/>
            <p:nvPr/>
          </p:nvSpPr>
          <p:spPr>
            <a:xfrm>
              <a:off x="1324080" y="1798560"/>
              <a:ext cx="2933640" cy="29037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324080" y="4124160"/>
              <a:ext cx="2933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324080" y="3546360"/>
              <a:ext cx="2933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324080" y="2954160"/>
              <a:ext cx="2933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324080" y="2376360"/>
              <a:ext cx="2933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324080" y="1798560"/>
              <a:ext cx="2933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324080" y="1798560"/>
              <a:ext cx="2933640" cy="2903760"/>
            </a:xfrm>
            <a:prstGeom prst="rect">
              <a:avLst/>
            </a:prstGeom>
            <a:noFill/>
            <a:ln w="158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324080" y="1798560"/>
              <a:ext cx="1440" cy="290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324080" y="470232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324080" y="441324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324080" y="41241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324080" y="35463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324080" y="29541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324080" y="23763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324080" y="179856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324080" y="4702320"/>
              <a:ext cx="2933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1324080" y="4672080"/>
              <a:ext cx="144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1916280" y="4672080"/>
              <a:ext cx="144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2494080" y="4672080"/>
              <a:ext cx="144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3087720" y="4672080"/>
              <a:ext cx="144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3665520" y="4672080"/>
              <a:ext cx="180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4257720" y="4672080"/>
              <a:ext cx="144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324080" y="1860480"/>
              <a:ext cx="2933640" cy="2841840"/>
            </a:xfrm>
            <a:custGeom>
              <a:avLst/>
              <a:gdLst/>
              <a:ahLst/>
              <a:rect l="l" t="t" r="r" b="b"/>
              <a:pathLst>
                <a:path w="193" h="187">
                  <a:moveTo>
                    <a:pt x="193" y="0"/>
                  </a:moveTo>
                  <a:lnTo>
                    <a:pt x="193" y="4"/>
                  </a:lnTo>
                  <a:lnTo>
                    <a:pt x="183" y="4"/>
                  </a:lnTo>
                  <a:lnTo>
                    <a:pt x="183" y="7"/>
                  </a:lnTo>
                  <a:lnTo>
                    <a:pt x="183" y="11"/>
                  </a:lnTo>
                  <a:lnTo>
                    <a:pt x="174" y="11"/>
                  </a:lnTo>
                  <a:lnTo>
                    <a:pt x="174" y="15"/>
                  </a:lnTo>
                  <a:lnTo>
                    <a:pt x="174" y="19"/>
                  </a:lnTo>
                  <a:lnTo>
                    <a:pt x="174" y="23"/>
                  </a:lnTo>
                  <a:lnTo>
                    <a:pt x="164" y="23"/>
                  </a:lnTo>
                  <a:lnTo>
                    <a:pt x="154" y="23"/>
                  </a:lnTo>
                  <a:lnTo>
                    <a:pt x="154" y="27"/>
                  </a:lnTo>
                  <a:lnTo>
                    <a:pt x="145" y="27"/>
                  </a:lnTo>
                  <a:lnTo>
                    <a:pt x="145" y="30"/>
                  </a:lnTo>
                  <a:lnTo>
                    <a:pt x="145" y="34"/>
                  </a:lnTo>
                  <a:lnTo>
                    <a:pt x="135" y="34"/>
                  </a:lnTo>
                  <a:lnTo>
                    <a:pt x="125" y="34"/>
                  </a:lnTo>
                  <a:lnTo>
                    <a:pt x="125" y="38"/>
                  </a:lnTo>
                  <a:lnTo>
                    <a:pt x="125" y="42"/>
                  </a:lnTo>
                  <a:lnTo>
                    <a:pt x="125" y="46"/>
                  </a:lnTo>
                  <a:lnTo>
                    <a:pt x="125" y="53"/>
                  </a:lnTo>
                  <a:lnTo>
                    <a:pt x="125" y="53"/>
                  </a:lnTo>
                  <a:lnTo>
                    <a:pt x="116" y="53"/>
                  </a:lnTo>
                  <a:lnTo>
                    <a:pt x="116" y="57"/>
                  </a:lnTo>
                  <a:lnTo>
                    <a:pt x="116" y="61"/>
                  </a:lnTo>
                  <a:lnTo>
                    <a:pt x="106" y="61"/>
                  </a:lnTo>
                  <a:lnTo>
                    <a:pt x="106" y="65"/>
                  </a:lnTo>
                  <a:lnTo>
                    <a:pt x="106" y="69"/>
                  </a:lnTo>
                  <a:lnTo>
                    <a:pt x="97" y="69"/>
                  </a:lnTo>
                  <a:lnTo>
                    <a:pt x="87" y="69"/>
                  </a:lnTo>
                  <a:lnTo>
                    <a:pt x="77" y="69"/>
                  </a:lnTo>
                  <a:lnTo>
                    <a:pt x="77" y="72"/>
                  </a:lnTo>
                  <a:lnTo>
                    <a:pt x="77" y="76"/>
                  </a:lnTo>
                  <a:lnTo>
                    <a:pt x="77" y="80"/>
                  </a:lnTo>
                  <a:lnTo>
                    <a:pt x="77" y="84"/>
                  </a:lnTo>
                  <a:lnTo>
                    <a:pt x="77" y="88"/>
                  </a:lnTo>
                  <a:lnTo>
                    <a:pt x="77" y="92"/>
                  </a:lnTo>
                  <a:lnTo>
                    <a:pt x="68" y="92"/>
                  </a:lnTo>
                  <a:lnTo>
                    <a:pt x="58" y="92"/>
                  </a:lnTo>
                  <a:lnTo>
                    <a:pt x="48" y="92"/>
                  </a:lnTo>
                  <a:lnTo>
                    <a:pt x="48" y="95"/>
                  </a:lnTo>
                  <a:lnTo>
                    <a:pt x="39" y="95"/>
                  </a:lnTo>
                  <a:lnTo>
                    <a:pt x="29" y="95"/>
                  </a:lnTo>
                  <a:lnTo>
                    <a:pt x="29" y="99"/>
                  </a:lnTo>
                  <a:lnTo>
                    <a:pt x="29" y="103"/>
                  </a:lnTo>
                  <a:lnTo>
                    <a:pt x="29" y="107"/>
                  </a:lnTo>
                  <a:lnTo>
                    <a:pt x="29" y="111"/>
                  </a:lnTo>
                  <a:lnTo>
                    <a:pt x="29" y="114"/>
                  </a:lnTo>
                  <a:lnTo>
                    <a:pt x="29" y="118"/>
                  </a:lnTo>
                  <a:lnTo>
                    <a:pt x="29" y="122"/>
                  </a:lnTo>
                  <a:lnTo>
                    <a:pt x="29" y="126"/>
                  </a:lnTo>
                  <a:lnTo>
                    <a:pt x="29" y="130"/>
                  </a:lnTo>
                  <a:lnTo>
                    <a:pt x="19" y="130"/>
                  </a:lnTo>
                  <a:lnTo>
                    <a:pt x="19" y="134"/>
                  </a:lnTo>
                  <a:lnTo>
                    <a:pt x="19" y="137"/>
                  </a:lnTo>
                  <a:lnTo>
                    <a:pt x="19" y="141"/>
                  </a:lnTo>
                  <a:lnTo>
                    <a:pt x="19" y="145"/>
                  </a:lnTo>
                  <a:lnTo>
                    <a:pt x="19" y="149"/>
                  </a:lnTo>
                  <a:lnTo>
                    <a:pt x="10" y="149"/>
                  </a:lnTo>
                  <a:lnTo>
                    <a:pt x="10" y="153"/>
                  </a:lnTo>
                  <a:lnTo>
                    <a:pt x="10" y="156"/>
                  </a:lnTo>
                  <a:lnTo>
                    <a:pt x="10" y="160"/>
                  </a:lnTo>
                  <a:lnTo>
                    <a:pt x="0" y="160"/>
                  </a:lnTo>
                  <a:lnTo>
                    <a:pt x="0" y="164"/>
                  </a:lnTo>
                  <a:lnTo>
                    <a:pt x="0" y="168"/>
                  </a:lnTo>
                  <a:lnTo>
                    <a:pt x="0" y="172"/>
                  </a:lnTo>
                  <a:lnTo>
                    <a:pt x="0" y="176"/>
                  </a:lnTo>
                  <a:lnTo>
                    <a:pt x="0" y="179"/>
                  </a:lnTo>
                  <a:lnTo>
                    <a:pt x="0" y="183"/>
                  </a:lnTo>
                  <a:lnTo>
                    <a:pt x="0" y="187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211640" y="1814400"/>
              <a:ext cx="9216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211640" y="187488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059360" y="1874880"/>
              <a:ext cx="9180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059360" y="1920960"/>
              <a:ext cx="9180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059360" y="1981080"/>
              <a:ext cx="9180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922560" y="198108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922560" y="2043000"/>
              <a:ext cx="9216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922560" y="210348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922560" y="216360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772080" y="216360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619440" y="2163600"/>
              <a:ext cx="9072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619440" y="2224080"/>
              <a:ext cx="9072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483000" y="222408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483000" y="227016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483000" y="233028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330720" y="233028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178080" y="233028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178080" y="2392200"/>
              <a:ext cx="9216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178080" y="245268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178080" y="2513160"/>
              <a:ext cx="92160" cy="9180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178080" y="261936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178080" y="261936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041640" y="261936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041640" y="2681280"/>
              <a:ext cx="9036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041640" y="2741760"/>
              <a:ext cx="9036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889360" y="27417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889360" y="280188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889360" y="286380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752920" y="2863800"/>
              <a:ext cx="9180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600280" y="286380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449440" y="2863800"/>
              <a:ext cx="9072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8" y="0"/>
                  </a:moveTo>
                  <a:lnTo>
                    <a:pt x="57" y="28"/>
                  </a:lnTo>
                  <a:lnTo>
                    <a:pt x="28" y="57"/>
                  </a:lnTo>
                  <a:lnTo>
                    <a:pt x="0" y="28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449440" y="2908440"/>
              <a:ext cx="90720" cy="9180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449440" y="2970360"/>
              <a:ext cx="9072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8" y="0"/>
                  </a:moveTo>
                  <a:lnTo>
                    <a:pt x="57" y="28"/>
                  </a:lnTo>
                  <a:lnTo>
                    <a:pt x="28" y="57"/>
                  </a:lnTo>
                  <a:lnTo>
                    <a:pt x="0" y="28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449440" y="3030480"/>
              <a:ext cx="9072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8" y="0"/>
                  </a:moveTo>
                  <a:lnTo>
                    <a:pt x="57" y="29"/>
                  </a:lnTo>
                  <a:lnTo>
                    <a:pt x="28" y="57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449440" y="3090960"/>
              <a:ext cx="90720" cy="9180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449440" y="3151080"/>
              <a:ext cx="9072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8" y="0"/>
                  </a:moveTo>
                  <a:lnTo>
                    <a:pt x="57" y="29"/>
                  </a:lnTo>
                  <a:lnTo>
                    <a:pt x="28" y="58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449440" y="3213000"/>
              <a:ext cx="9072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8" y="0"/>
                  </a:moveTo>
                  <a:lnTo>
                    <a:pt x="57" y="29"/>
                  </a:lnTo>
                  <a:lnTo>
                    <a:pt x="28" y="57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311560" y="3213000"/>
              <a:ext cx="9180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160720" y="3213000"/>
              <a:ext cx="9036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8" y="0"/>
                  </a:moveTo>
                  <a:lnTo>
                    <a:pt x="57" y="29"/>
                  </a:lnTo>
                  <a:lnTo>
                    <a:pt x="28" y="57"/>
                  </a:lnTo>
                  <a:lnTo>
                    <a:pt x="0" y="29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008080" y="3213000"/>
              <a:ext cx="9072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008080" y="3259080"/>
              <a:ext cx="9072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871640" y="3259080"/>
              <a:ext cx="9036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8" y="0"/>
                  </a:moveTo>
                  <a:lnTo>
                    <a:pt x="57" y="28"/>
                  </a:lnTo>
                  <a:lnTo>
                    <a:pt x="28" y="57"/>
                  </a:lnTo>
                  <a:lnTo>
                    <a:pt x="0" y="28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719360" y="3259080"/>
              <a:ext cx="9036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719360" y="3319560"/>
              <a:ext cx="9036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719360" y="337968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719360" y="344016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719360" y="3502080"/>
              <a:ext cx="9036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719360" y="354636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719360" y="3608280"/>
              <a:ext cx="9036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719360" y="3668760"/>
              <a:ext cx="9036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719360" y="3728880"/>
              <a:ext cx="90360" cy="92160"/>
            </a:xfrm>
            <a:custGeom>
              <a:avLst/>
              <a:gdLst/>
              <a:ahLst/>
              <a:rect l="l" t="t" r="r" b="b"/>
              <a:pathLst>
                <a:path w="57" h="58">
                  <a:moveTo>
                    <a:pt x="29" y="0"/>
                  </a:moveTo>
                  <a:lnTo>
                    <a:pt x="57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719360" y="3790800"/>
              <a:ext cx="9036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29" y="0"/>
                  </a:moveTo>
                  <a:lnTo>
                    <a:pt x="57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566720" y="3790800"/>
              <a:ext cx="9216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566720" y="385128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566720" y="38973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566720" y="3957480"/>
              <a:ext cx="9216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566720" y="401796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566720" y="407988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430280" y="407988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430280" y="41403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430280" y="4186080"/>
              <a:ext cx="92160" cy="9072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430280" y="42465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278000" y="42465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278000" y="4307040"/>
              <a:ext cx="92160" cy="9180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278000" y="4367160"/>
              <a:ext cx="92160" cy="9216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278000" y="442908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278000" y="44895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278000" y="453564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8"/>
                  </a:lnTo>
                  <a:lnTo>
                    <a:pt x="29" y="57"/>
                  </a:lnTo>
                  <a:lnTo>
                    <a:pt x="0" y="2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278000" y="4595760"/>
              <a:ext cx="92160" cy="90360"/>
            </a:xfrm>
            <a:custGeom>
              <a:avLst/>
              <a:gdLst/>
              <a:ahLst/>
              <a:rect l="l" t="t" r="r" b="b"/>
              <a:pathLst>
                <a:path w="58" h="57">
                  <a:moveTo>
                    <a:pt x="29" y="0"/>
                  </a:moveTo>
                  <a:lnTo>
                    <a:pt x="58" y="29"/>
                  </a:lnTo>
                  <a:lnTo>
                    <a:pt x="29" y="57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278000" y="4656240"/>
              <a:ext cx="92160" cy="91800"/>
            </a:xfrm>
            <a:custGeom>
              <a:avLst/>
              <a:gdLst/>
              <a:ahLst/>
              <a:rect l="l" t="t" r="r" b="b"/>
              <a:pathLst>
                <a:path w="58" h="58">
                  <a:moveTo>
                    <a:pt x="29" y="0"/>
                  </a:moveTo>
                  <a:lnTo>
                    <a:pt x="58" y="29"/>
                  </a:lnTo>
                  <a:lnTo>
                    <a:pt x="29" y="58"/>
                  </a:lnTo>
                  <a:lnTo>
                    <a:pt x="0" y="29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000000"/>
            </a:solidFill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226520" y="479736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689120" y="47973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300400" y="47973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913120" y="47973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524400" y="47973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137120" y="47973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088640" y="464652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939960" y="40593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939960" y="34718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939960" y="287640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939960" y="22892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939960" y="170172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1906560" y="1807920"/>
              <a:ext cx="12600" cy="291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H="1" flipV="1">
              <a:off x="2476080" y="1773000"/>
              <a:ext cx="25560" cy="2933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3090960" y="1779480"/>
              <a:ext cx="1440" cy="2919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3662280" y="1779120"/>
              <a:ext cx="1800" cy="292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2633760" y="4214880"/>
              <a:ext cx="1511280" cy="42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iR-21 AUC=0.61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9" name=""/>
          <p:cNvGrpSpPr/>
          <p:nvPr/>
        </p:nvGrpSpPr>
        <p:grpSpPr>
          <a:xfrm>
            <a:off x="4845240" y="1689120"/>
            <a:ext cx="3417840" cy="3309120"/>
            <a:chOff x="4845240" y="1689120"/>
            <a:chExt cx="3417840" cy="3309120"/>
          </a:xfrm>
        </p:grpSpPr>
        <p:sp>
          <p:nvSpPr>
            <p:cNvPr id="160" name=""/>
            <p:cNvSpPr/>
            <p:nvPr/>
          </p:nvSpPr>
          <p:spPr>
            <a:xfrm>
              <a:off x="5235480" y="1781280"/>
              <a:ext cx="2946600" cy="2919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5235480" y="4116600"/>
              <a:ext cx="294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235480" y="3532320"/>
              <a:ext cx="294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5235480" y="2948040"/>
              <a:ext cx="2946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235480" y="2363760"/>
              <a:ext cx="2946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235480" y="1781280"/>
              <a:ext cx="294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235480" y="1781280"/>
              <a:ext cx="2946600" cy="2919240"/>
            </a:xfrm>
            <a:prstGeom prst="rect">
              <a:avLst/>
            </a:prstGeom>
            <a:noFill/>
            <a:ln w="144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235480" y="1781280"/>
              <a:ext cx="1800" cy="2919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235480" y="4700520"/>
              <a:ext cx="28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235480" y="4116600"/>
              <a:ext cx="28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235480" y="3532320"/>
              <a:ext cx="28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235480" y="2948040"/>
              <a:ext cx="28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235480" y="2363760"/>
              <a:ext cx="28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235480" y="1781280"/>
              <a:ext cx="28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235480" y="4700520"/>
              <a:ext cx="2946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V="1">
              <a:off x="5235480" y="4671720"/>
              <a:ext cx="180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5819760" y="4671720"/>
              <a:ext cx="180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V="1">
              <a:off x="6416640" y="4671720"/>
              <a:ext cx="180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V="1">
              <a:off x="7000920" y="4671720"/>
              <a:ext cx="144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7597800" y="4671720"/>
              <a:ext cx="144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flipV="1">
              <a:off x="8182080" y="4671720"/>
              <a:ext cx="144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5235480" y="1781280"/>
              <a:ext cx="2946600" cy="2863800"/>
            </a:xfrm>
            <a:custGeom>
              <a:avLst/>
              <a:gdLst/>
              <a:ahLst/>
              <a:rect l="l" t="t" r="r" b="b"/>
              <a:pathLst>
                <a:path w="212" h="206">
                  <a:moveTo>
                    <a:pt x="0" y="206"/>
                  </a:moveTo>
                  <a:lnTo>
                    <a:pt x="0" y="202"/>
                  </a:lnTo>
                  <a:lnTo>
                    <a:pt x="0" y="197"/>
                  </a:lnTo>
                  <a:lnTo>
                    <a:pt x="0" y="193"/>
                  </a:lnTo>
                  <a:lnTo>
                    <a:pt x="0" y="189"/>
                  </a:lnTo>
                  <a:lnTo>
                    <a:pt x="0" y="185"/>
                  </a:lnTo>
                  <a:lnTo>
                    <a:pt x="0" y="181"/>
                  </a:lnTo>
                  <a:lnTo>
                    <a:pt x="0" y="176"/>
                  </a:lnTo>
                  <a:lnTo>
                    <a:pt x="0" y="172"/>
                  </a:lnTo>
                  <a:lnTo>
                    <a:pt x="0" y="168"/>
                  </a:lnTo>
                  <a:lnTo>
                    <a:pt x="0" y="164"/>
                  </a:lnTo>
                  <a:lnTo>
                    <a:pt x="0" y="160"/>
                  </a:lnTo>
                  <a:lnTo>
                    <a:pt x="0" y="155"/>
                  </a:lnTo>
                  <a:lnTo>
                    <a:pt x="0" y="151"/>
                  </a:lnTo>
                  <a:lnTo>
                    <a:pt x="0" y="147"/>
                  </a:lnTo>
                  <a:lnTo>
                    <a:pt x="11" y="147"/>
                  </a:lnTo>
                  <a:lnTo>
                    <a:pt x="11" y="143"/>
                  </a:lnTo>
                  <a:lnTo>
                    <a:pt x="11" y="139"/>
                  </a:lnTo>
                  <a:lnTo>
                    <a:pt x="11" y="134"/>
                  </a:lnTo>
                  <a:lnTo>
                    <a:pt x="11" y="130"/>
                  </a:lnTo>
                  <a:lnTo>
                    <a:pt x="11" y="126"/>
                  </a:lnTo>
                  <a:lnTo>
                    <a:pt x="11" y="122"/>
                  </a:lnTo>
                  <a:lnTo>
                    <a:pt x="21" y="122"/>
                  </a:lnTo>
                  <a:lnTo>
                    <a:pt x="21" y="118"/>
                  </a:lnTo>
                  <a:lnTo>
                    <a:pt x="21" y="113"/>
                  </a:lnTo>
                  <a:lnTo>
                    <a:pt x="21" y="109"/>
                  </a:lnTo>
                  <a:lnTo>
                    <a:pt x="21" y="105"/>
                  </a:lnTo>
                  <a:lnTo>
                    <a:pt x="21" y="101"/>
                  </a:lnTo>
                  <a:lnTo>
                    <a:pt x="21" y="97"/>
                  </a:lnTo>
                  <a:lnTo>
                    <a:pt x="21" y="92"/>
                  </a:lnTo>
                  <a:lnTo>
                    <a:pt x="21" y="88"/>
                  </a:lnTo>
                  <a:lnTo>
                    <a:pt x="21" y="84"/>
                  </a:lnTo>
                  <a:lnTo>
                    <a:pt x="32" y="84"/>
                  </a:lnTo>
                  <a:lnTo>
                    <a:pt x="32" y="80"/>
                  </a:lnTo>
                  <a:lnTo>
                    <a:pt x="32" y="76"/>
                  </a:lnTo>
                  <a:lnTo>
                    <a:pt x="32" y="71"/>
                  </a:lnTo>
                  <a:lnTo>
                    <a:pt x="32" y="67"/>
                  </a:lnTo>
                  <a:lnTo>
                    <a:pt x="32" y="63"/>
                  </a:lnTo>
                  <a:lnTo>
                    <a:pt x="42" y="63"/>
                  </a:lnTo>
                  <a:lnTo>
                    <a:pt x="53" y="63"/>
                  </a:lnTo>
                  <a:lnTo>
                    <a:pt x="53" y="59"/>
                  </a:lnTo>
                  <a:lnTo>
                    <a:pt x="53" y="55"/>
                  </a:lnTo>
                  <a:lnTo>
                    <a:pt x="53" y="50"/>
                  </a:lnTo>
                  <a:lnTo>
                    <a:pt x="53" y="46"/>
                  </a:lnTo>
                  <a:lnTo>
                    <a:pt x="64" y="46"/>
                  </a:lnTo>
                  <a:lnTo>
                    <a:pt x="64" y="42"/>
                  </a:lnTo>
                  <a:lnTo>
                    <a:pt x="74" y="42"/>
                  </a:lnTo>
                  <a:lnTo>
                    <a:pt x="74" y="38"/>
                  </a:lnTo>
                  <a:lnTo>
                    <a:pt x="74" y="34"/>
                  </a:lnTo>
                  <a:lnTo>
                    <a:pt x="74" y="29"/>
                  </a:lnTo>
                  <a:lnTo>
                    <a:pt x="74" y="25"/>
                  </a:lnTo>
                  <a:lnTo>
                    <a:pt x="74" y="21"/>
                  </a:lnTo>
                  <a:lnTo>
                    <a:pt x="74" y="17"/>
                  </a:lnTo>
                  <a:lnTo>
                    <a:pt x="85" y="17"/>
                  </a:lnTo>
                  <a:lnTo>
                    <a:pt x="95" y="17"/>
                  </a:lnTo>
                  <a:lnTo>
                    <a:pt x="106" y="17"/>
                  </a:lnTo>
                  <a:lnTo>
                    <a:pt x="117" y="17"/>
                  </a:lnTo>
                  <a:lnTo>
                    <a:pt x="127" y="17"/>
                  </a:lnTo>
                  <a:lnTo>
                    <a:pt x="138" y="17"/>
                  </a:lnTo>
                  <a:lnTo>
                    <a:pt x="148" y="17"/>
                  </a:lnTo>
                  <a:lnTo>
                    <a:pt x="148" y="13"/>
                  </a:lnTo>
                  <a:lnTo>
                    <a:pt x="159" y="13"/>
                  </a:lnTo>
                  <a:lnTo>
                    <a:pt x="170" y="13"/>
                  </a:lnTo>
                  <a:lnTo>
                    <a:pt x="170" y="8"/>
                  </a:lnTo>
                  <a:lnTo>
                    <a:pt x="180" y="8"/>
                  </a:lnTo>
                  <a:lnTo>
                    <a:pt x="191" y="8"/>
                  </a:lnTo>
                  <a:lnTo>
                    <a:pt x="191" y="4"/>
                  </a:lnTo>
                  <a:lnTo>
                    <a:pt x="191" y="0"/>
                  </a:lnTo>
                  <a:lnTo>
                    <a:pt x="201" y="0"/>
                  </a:lnTo>
                  <a:lnTo>
                    <a:pt x="212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194440" y="4603680"/>
              <a:ext cx="82440" cy="8280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5194440" y="454824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194440" y="447840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194440" y="442296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194440" y="4367160"/>
              <a:ext cx="82440" cy="8280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194440" y="431172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194440" y="425628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194440" y="418644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194440" y="4130640"/>
              <a:ext cx="82440" cy="8280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5194440" y="407520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194440" y="401976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5194440" y="3963960"/>
              <a:ext cx="82440" cy="8280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194440" y="3894120"/>
              <a:ext cx="82440" cy="8280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194440" y="383868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194440" y="378324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346720" y="3783240"/>
              <a:ext cx="84240" cy="82440"/>
            </a:xfrm>
            <a:custGeom>
              <a:avLst/>
              <a:gdLst/>
              <a:ahLst/>
              <a:rect l="l" t="t" r="r" b="b"/>
              <a:pathLst>
                <a:path w="53" h="52">
                  <a:moveTo>
                    <a:pt x="26" y="0"/>
                  </a:moveTo>
                  <a:lnTo>
                    <a:pt x="53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346720" y="3727440"/>
              <a:ext cx="84240" cy="82800"/>
            </a:xfrm>
            <a:custGeom>
              <a:avLst/>
              <a:gdLst/>
              <a:ahLst/>
              <a:rect l="l" t="t" r="r" b="b"/>
              <a:pathLst>
                <a:path w="53" h="52">
                  <a:moveTo>
                    <a:pt x="26" y="0"/>
                  </a:moveTo>
                  <a:lnTo>
                    <a:pt x="53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346720" y="3672000"/>
              <a:ext cx="84240" cy="82440"/>
            </a:xfrm>
            <a:custGeom>
              <a:avLst/>
              <a:gdLst/>
              <a:ahLst/>
              <a:rect l="l" t="t" r="r" b="b"/>
              <a:pathLst>
                <a:path w="53" h="52">
                  <a:moveTo>
                    <a:pt x="26" y="0"/>
                  </a:moveTo>
                  <a:lnTo>
                    <a:pt x="53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346720" y="3602160"/>
              <a:ext cx="84240" cy="8424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6" y="0"/>
                  </a:moveTo>
                  <a:lnTo>
                    <a:pt x="53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5346720" y="3546720"/>
              <a:ext cx="84240" cy="82440"/>
            </a:xfrm>
            <a:custGeom>
              <a:avLst/>
              <a:gdLst/>
              <a:ahLst/>
              <a:rect l="l" t="t" r="r" b="b"/>
              <a:pathLst>
                <a:path w="53" h="52">
                  <a:moveTo>
                    <a:pt x="26" y="0"/>
                  </a:moveTo>
                  <a:lnTo>
                    <a:pt x="53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5346720" y="3490920"/>
              <a:ext cx="84240" cy="82800"/>
            </a:xfrm>
            <a:custGeom>
              <a:avLst/>
              <a:gdLst/>
              <a:ahLst/>
              <a:rect l="l" t="t" r="r" b="b"/>
              <a:pathLst>
                <a:path w="53" h="52">
                  <a:moveTo>
                    <a:pt x="26" y="0"/>
                  </a:moveTo>
                  <a:lnTo>
                    <a:pt x="53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5346720" y="3435480"/>
              <a:ext cx="84240" cy="82440"/>
            </a:xfrm>
            <a:custGeom>
              <a:avLst/>
              <a:gdLst/>
              <a:ahLst/>
              <a:rect l="l" t="t" r="r" b="b"/>
              <a:pathLst>
                <a:path w="53" h="52">
                  <a:moveTo>
                    <a:pt x="26" y="0"/>
                  </a:moveTo>
                  <a:lnTo>
                    <a:pt x="53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486400" y="343548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486400" y="338004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5486400" y="3310200"/>
              <a:ext cx="8244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486400" y="325440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486400" y="319896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486400" y="314352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5486400" y="3087720"/>
              <a:ext cx="82440" cy="82440"/>
            </a:xfrm>
            <a:custGeom>
              <a:avLst/>
              <a:gdLst/>
              <a:ahLst/>
              <a:rect l="l" t="t" r="r" b="b"/>
              <a:pathLst>
                <a:path w="52" h="52">
                  <a:moveTo>
                    <a:pt x="26" y="0"/>
                  </a:moveTo>
                  <a:lnTo>
                    <a:pt x="52" y="26"/>
                  </a:lnTo>
                  <a:lnTo>
                    <a:pt x="26" y="52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486400" y="301788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5486400" y="296244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486400" y="290664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638680" y="290664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638680" y="285120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638680" y="279576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5638680" y="2725920"/>
              <a:ext cx="8280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638680" y="267012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638680" y="261468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776920" y="2614680"/>
              <a:ext cx="84240" cy="8424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7" y="0"/>
                  </a:moveTo>
                  <a:lnTo>
                    <a:pt x="53" y="26"/>
                  </a:lnTo>
                  <a:lnTo>
                    <a:pt x="27" y="53"/>
                  </a:lnTo>
                  <a:lnTo>
                    <a:pt x="0" y="26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931000" y="261468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931000" y="2559240"/>
              <a:ext cx="8244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931000" y="250344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931000" y="243360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931000" y="237816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6083280" y="2378160"/>
              <a:ext cx="84240" cy="8424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6" y="0"/>
                  </a:moveTo>
                  <a:lnTo>
                    <a:pt x="53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083280" y="2322720"/>
              <a:ext cx="84240" cy="8388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6" y="0"/>
                  </a:moveTo>
                  <a:lnTo>
                    <a:pt x="53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6222960" y="2322720"/>
              <a:ext cx="8280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6222960" y="226692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6222960" y="221148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6222960" y="214164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6222960" y="2086200"/>
              <a:ext cx="8280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6222960" y="203040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6222960" y="197496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6375600" y="197496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6513480" y="1974960"/>
              <a:ext cx="84240" cy="8424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7" y="0"/>
                  </a:moveTo>
                  <a:lnTo>
                    <a:pt x="53" y="27"/>
                  </a:lnTo>
                  <a:lnTo>
                    <a:pt x="27" y="53"/>
                  </a:lnTo>
                  <a:lnTo>
                    <a:pt x="0" y="27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6667560" y="197496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6819840" y="197496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6959520" y="1974960"/>
              <a:ext cx="8280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7112160" y="197496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7250040" y="1974960"/>
              <a:ext cx="84240" cy="8424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7" y="0"/>
                  </a:moveTo>
                  <a:lnTo>
                    <a:pt x="53" y="27"/>
                  </a:lnTo>
                  <a:lnTo>
                    <a:pt x="27" y="53"/>
                  </a:lnTo>
                  <a:lnTo>
                    <a:pt x="0" y="27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7250040" y="1919520"/>
              <a:ext cx="84240" cy="8388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7" y="0"/>
                  </a:moveTo>
                  <a:lnTo>
                    <a:pt x="53" y="26"/>
                  </a:lnTo>
                  <a:lnTo>
                    <a:pt x="27" y="53"/>
                  </a:lnTo>
                  <a:lnTo>
                    <a:pt x="0" y="26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7404120" y="1919520"/>
              <a:ext cx="8244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7556400" y="1919520"/>
              <a:ext cx="8280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6"/>
                  </a:lnTo>
                  <a:lnTo>
                    <a:pt x="26" y="53"/>
                  </a:lnTo>
                  <a:lnTo>
                    <a:pt x="0" y="26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7556400" y="1849680"/>
              <a:ext cx="8280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7694640" y="1849680"/>
              <a:ext cx="84240" cy="8388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7" y="0"/>
                  </a:moveTo>
                  <a:lnTo>
                    <a:pt x="53" y="27"/>
                  </a:lnTo>
                  <a:lnTo>
                    <a:pt x="27" y="53"/>
                  </a:lnTo>
                  <a:lnTo>
                    <a:pt x="0" y="27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7848720" y="1849680"/>
              <a:ext cx="82440" cy="8388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7848720" y="179388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7848720" y="173844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7986600" y="1738440"/>
              <a:ext cx="84240" cy="84240"/>
            </a:xfrm>
            <a:custGeom>
              <a:avLst/>
              <a:gdLst/>
              <a:ahLst/>
              <a:rect l="l" t="t" r="r" b="b"/>
              <a:pathLst>
                <a:path w="53" h="53">
                  <a:moveTo>
                    <a:pt x="27" y="0"/>
                  </a:moveTo>
                  <a:lnTo>
                    <a:pt x="53" y="27"/>
                  </a:lnTo>
                  <a:lnTo>
                    <a:pt x="27" y="53"/>
                  </a:lnTo>
                  <a:lnTo>
                    <a:pt x="0" y="27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8140680" y="1738440"/>
              <a:ext cx="82440" cy="84240"/>
            </a:xfrm>
            <a:custGeom>
              <a:avLst/>
              <a:gdLst/>
              <a:ahLst/>
              <a:rect l="l" t="t" r="r" b="b"/>
              <a:pathLst>
                <a:path w="52" h="53">
                  <a:moveTo>
                    <a:pt x="26" y="0"/>
                  </a:moveTo>
                  <a:lnTo>
                    <a:pt x="52" y="27"/>
                  </a:lnTo>
                  <a:lnTo>
                    <a:pt x="26" y="53"/>
                  </a:lnTo>
                  <a:lnTo>
                    <a:pt x="0" y="27"/>
                  </a:lnTo>
                  <a:lnTo>
                    <a:pt x="26" y="0"/>
                  </a:lnTo>
                  <a:close/>
                </a:path>
              </a:pathLst>
            </a:custGeom>
            <a:solidFill>
              <a:srgbClr val="000000"/>
            </a:solidFill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103360" y="478476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565960" y="47847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6177240" y="47847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6789960" y="47847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7401240" y="47847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8013960" y="47847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993920" y="4633920"/>
              <a:ext cx="99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845240" y="404676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4845240" y="34592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845240" y="286380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845240" y="227664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845240" y="1689120"/>
              <a:ext cx="249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 flipV="1">
              <a:off x="5816520" y="1773000"/>
              <a:ext cx="1800" cy="292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6418440" y="1773000"/>
              <a:ext cx="1440" cy="292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flipV="1">
              <a:off x="7000920" y="1779480"/>
              <a:ext cx="1440" cy="292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 flipV="1">
              <a:off x="7602480" y="1785600"/>
              <a:ext cx="1800" cy="2925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6540480" y="4208400"/>
              <a:ext cx="1511280" cy="42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iR-375 AUC=0.80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9" name=""/>
          <p:cNvSpPr/>
          <p:nvPr/>
        </p:nvSpPr>
        <p:spPr>
          <a:xfrm>
            <a:off x="1157400" y="1052640"/>
            <a:ext cx="2156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5080320" y="1044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1979640" y="5084640"/>
            <a:ext cx="151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6029280" y="5051520"/>
            <a:ext cx="151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rot="16200000">
            <a:off x="40680" y="3064320"/>
            <a:ext cx="122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rot="16200000">
            <a:off x="3978720" y="3034440"/>
            <a:ext cx="12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5T10:52:57Z</dcterms:created>
  <dc:creator>Shuhei Komatsu</dc:creator>
  <dc:description/>
  <dc:language>en-US</dc:language>
  <cp:lastModifiedBy>Shuhei Komatsu</cp:lastModifiedBy>
  <dcterms:modified xsi:type="dcterms:W3CDTF">2010-12-30T03:47:01Z</dcterms:modified>
  <cp:revision>66</cp:revision>
  <dc:subject/>
  <dc:title>スライド 1</dc:title>
</cp:coreProperties>
</file>